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67" r:id="rId2"/>
  </p:sldIdLst>
  <p:sldSz cx="10058400" cy="5486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2" d="100"/>
          <a:sy n="112" d="100"/>
        </p:scale>
        <p:origin x="116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897890"/>
            <a:ext cx="7543800" cy="1910080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2881630"/>
            <a:ext cx="7543800" cy="1324610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49160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08643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292100"/>
            <a:ext cx="2168843" cy="46494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292100"/>
            <a:ext cx="6380798" cy="464947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140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07848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367791"/>
            <a:ext cx="8675370" cy="2282190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671571"/>
            <a:ext cx="8675370" cy="1200150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>
                    <a:tint val="75000"/>
                  </a:schemeClr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261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460500"/>
            <a:ext cx="4274820" cy="34810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460500"/>
            <a:ext cx="4274820" cy="34810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9817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292101"/>
            <a:ext cx="8675370" cy="10604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344930"/>
            <a:ext cx="4255174" cy="65913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04060"/>
            <a:ext cx="4255174" cy="29476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344930"/>
            <a:ext cx="4276130" cy="659130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04060"/>
            <a:ext cx="4276130" cy="294767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3043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5554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53653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65760"/>
            <a:ext cx="3244096" cy="12801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789940"/>
            <a:ext cx="5092065" cy="3898900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645920"/>
            <a:ext cx="3244096" cy="3049270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5027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65760"/>
            <a:ext cx="3244096" cy="12801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789940"/>
            <a:ext cx="5092065" cy="3898900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645920"/>
            <a:ext cx="3244096" cy="3049270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14282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292101"/>
            <a:ext cx="8675370" cy="10604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460500"/>
            <a:ext cx="8675370" cy="34810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085080"/>
            <a:ext cx="226314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7E73EC-6251-45EA-BC03-B9469F23B195}" type="datetimeFigureOut">
              <a:rPr lang="ko-KR" altLang="en-US" smtClean="0"/>
              <a:t>2024-02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085080"/>
            <a:ext cx="339471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085080"/>
            <a:ext cx="226314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3AC166-718C-4980-A2EC-D7A8FEF3502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8183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0CA92DA-C186-4DB8-A72A-88A83F5B2ED9}"/>
              </a:ext>
            </a:extLst>
          </p:cNvPr>
          <p:cNvSpPr/>
          <p:nvPr/>
        </p:nvSpPr>
        <p:spPr>
          <a:xfrm>
            <a:off x="288389" y="4681040"/>
            <a:ext cx="954492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altLang="ko-KR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lative abundance (%) of some compounds (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istein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echin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ringenin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unin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gibberellin A4, 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inkoglide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B, 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coxyloganin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thromboxane B2, 6-gingerol, sucrose, trans-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innamic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cid and uridine) in seven different moss samples</a:t>
            </a:r>
            <a:endParaRPr lang="ko-KR" altLang="ko-KR" sz="1600" dirty="0">
              <a:effectLst/>
              <a:latin typeface="Times New Roman" panose="02020603050405020304" pitchFamily="18" charset="0"/>
              <a:ea typeface="Malgun Gothic" panose="020B0503020000020004" pitchFamily="34" charset="-127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018" y="0"/>
            <a:ext cx="8033670" cy="4720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8189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654</TotalTime>
  <Words>4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맑은 고딕</vt:lpstr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emslab</dc:creator>
  <cp:lastModifiedBy>EEMS_8</cp:lastModifiedBy>
  <cp:revision>185</cp:revision>
  <dcterms:created xsi:type="dcterms:W3CDTF">2023-08-29T05:56:13Z</dcterms:created>
  <dcterms:modified xsi:type="dcterms:W3CDTF">2024-02-20T06:49:43Z</dcterms:modified>
</cp:coreProperties>
</file>